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92" r:id="rId1"/>
  </p:sldMasterIdLst>
  <p:notesMasterIdLst>
    <p:notesMasterId r:id="rId13"/>
  </p:notesMasterIdLst>
  <p:sldIdLst>
    <p:sldId id="270" r:id="rId2"/>
    <p:sldId id="277" r:id="rId3"/>
    <p:sldId id="280" r:id="rId4"/>
    <p:sldId id="282" r:id="rId5"/>
    <p:sldId id="281" r:id="rId6"/>
    <p:sldId id="283" r:id="rId7"/>
    <p:sldId id="284" r:id="rId8"/>
    <p:sldId id="285" r:id="rId9"/>
    <p:sldId id="286" r:id="rId10"/>
    <p:sldId id="287" r:id="rId11"/>
    <p:sldId id="288" r:id="rId12"/>
  </p:sldIdLst>
  <p:sldSz cx="8280400" cy="7019925"/>
  <p:notesSz cx="6808788" cy="99409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211" userDrawn="1">
          <p15:clr>
            <a:srgbClr val="A4A3A4"/>
          </p15:clr>
        </p15:guide>
        <p15:guide id="2" pos="260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6340" autoAdjust="0"/>
  </p:normalViewPr>
  <p:slideViewPr>
    <p:cSldViewPr snapToGrid="0">
      <p:cViewPr varScale="1">
        <p:scale>
          <a:sx n="107" d="100"/>
          <a:sy n="107" d="100"/>
        </p:scale>
        <p:origin x="-1338" y="-78"/>
      </p:cViewPr>
      <p:guideLst>
        <p:guide orient="horz" pos="2211"/>
        <p:guide pos="260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1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56038" y="0"/>
            <a:ext cx="29511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0E9263-3439-48B5-9443-29517C4DF06D}" type="datetimeFigureOut">
              <a:rPr lang="en-US" smtClean="0"/>
              <a:t>9/20/2023</a:t>
            </a:fld>
            <a:endParaRPr lang="en-U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206500" y="746125"/>
            <a:ext cx="4395788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1038" y="4721225"/>
            <a:ext cx="5446712" cy="44735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9442450"/>
            <a:ext cx="295116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56038" y="9442450"/>
            <a:ext cx="2951162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85477B-EA10-4333-9FAC-9EDF4FA7DB84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6409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1pPr>
    <a:lvl2pPr marL="342123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2pPr>
    <a:lvl3pPr marL="684246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3pPr>
    <a:lvl4pPr marL="1026368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4pPr>
    <a:lvl5pPr marL="1368491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5pPr>
    <a:lvl6pPr marL="1710614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6pPr>
    <a:lvl7pPr marL="2052737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7pPr>
    <a:lvl8pPr marL="2394859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8pPr>
    <a:lvl9pPr marL="2736982" algn="l" defTabSz="684246" rtl="0" eaLnBrk="1" latinLnBrk="0" hangingPunct="1">
      <a:defRPr sz="89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21030" y="1148863"/>
            <a:ext cx="7038340" cy="2443974"/>
          </a:xfrm>
        </p:spPr>
        <p:txBody>
          <a:bodyPr anchor="b"/>
          <a:lstStyle>
            <a:lvl1pPr algn="ctr">
              <a:defRPr sz="543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35050" y="3687086"/>
            <a:ext cx="6210300" cy="1694856"/>
          </a:xfrm>
        </p:spPr>
        <p:txBody>
          <a:bodyPr/>
          <a:lstStyle>
            <a:lvl1pPr marL="0" indent="0" algn="ctr">
              <a:buNone/>
              <a:defRPr sz="2173"/>
            </a:lvl1pPr>
            <a:lvl2pPr marL="414040" indent="0" algn="ctr">
              <a:buNone/>
              <a:defRPr sz="1811"/>
            </a:lvl2pPr>
            <a:lvl3pPr marL="828081" indent="0" algn="ctr">
              <a:buNone/>
              <a:defRPr sz="1630"/>
            </a:lvl3pPr>
            <a:lvl4pPr marL="1242121" indent="0" algn="ctr">
              <a:buNone/>
              <a:defRPr sz="1449"/>
            </a:lvl4pPr>
            <a:lvl5pPr marL="1656161" indent="0" algn="ctr">
              <a:buNone/>
              <a:defRPr sz="1449"/>
            </a:lvl5pPr>
            <a:lvl6pPr marL="2070202" indent="0" algn="ctr">
              <a:buNone/>
              <a:defRPr sz="1449"/>
            </a:lvl6pPr>
            <a:lvl7pPr marL="2484242" indent="0" algn="ctr">
              <a:buNone/>
              <a:defRPr sz="1449"/>
            </a:lvl7pPr>
            <a:lvl8pPr marL="2898282" indent="0" algn="ctr">
              <a:buNone/>
              <a:defRPr sz="1449"/>
            </a:lvl8pPr>
            <a:lvl9pPr marL="3312323" indent="0" algn="ctr">
              <a:buNone/>
              <a:defRPr sz="1449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617631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947446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925662" y="373746"/>
            <a:ext cx="1785461" cy="5949062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69278" y="373746"/>
            <a:ext cx="5252879" cy="5949062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87876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27215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64965" y="1750108"/>
            <a:ext cx="7141845" cy="2920093"/>
          </a:xfrm>
        </p:spPr>
        <p:txBody>
          <a:bodyPr anchor="b"/>
          <a:lstStyle>
            <a:lvl1pPr>
              <a:defRPr sz="543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4965" y="4697827"/>
            <a:ext cx="7141845" cy="1535608"/>
          </a:xfrm>
        </p:spPr>
        <p:txBody>
          <a:bodyPr/>
          <a:lstStyle>
            <a:lvl1pPr marL="0" indent="0">
              <a:buNone/>
              <a:defRPr sz="2173">
                <a:solidFill>
                  <a:schemeClr val="tx1"/>
                </a:solidFill>
              </a:defRPr>
            </a:lvl1pPr>
            <a:lvl2pPr marL="414040" indent="0">
              <a:buNone/>
              <a:defRPr sz="1811">
                <a:solidFill>
                  <a:schemeClr val="tx1">
                    <a:tint val="75000"/>
                  </a:schemeClr>
                </a:solidFill>
              </a:defRPr>
            </a:lvl2pPr>
            <a:lvl3pPr marL="828081" indent="0">
              <a:buNone/>
              <a:defRPr sz="1630">
                <a:solidFill>
                  <a:schemeClr val="tx1">
                    <a:tint val="75000"/>
                  </a:schemeClr>
                </a:solidFill>
              </a:defRPr>
            </a:lvl3pPr>
            <a:lvl4pPr marL="1242121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4pPr>
            <a:lvl5pPr marL="1656161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5pPr>
            <a:lvl6pPr marL="207020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6pPr>
            <a:lvl7pPr marL="248424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7pPr>
            <a:lvl8pPr marL="2898282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8pPr>
            <a:lvl9pPr marL="3312323" indent="0">
              <a:buNone/>
              <a:defRPr sz="144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4195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69278" y="1868730"/>
            <a:ext cx="3519170" cy="445407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191953" y="1868730"/>
            <a:ext cx="3519170" cy="445407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486052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373748"/>
            <a:ext cx="7141845" cy="1356861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70357" y="1720857"/>
            <a:ext cx="3502997" cy="843365"/>
          </a:xfrm>
        </p:spPr>
        <p:txBody>
          <a:bodyPr anchor="b"/>
          <a:lstStyle>
            <a:lvl1pPr marL="0" indent="0">
              <a:buNone/>
              <a:defRPr sz="2173" b="1"/>
            </a:lvl1pPr>
            <a:lvl2pPr marL="414040" indent="0">
              <a:buNone/>
              <a:defRPr sz="1811" b="1"/>
            </a:lvl2pPr>
            <a:lvl3pPr marL="828081" indent="0">
              <a:buNone/>
              <a:defRPr sz="1630" b="1"/>
            </a:lvl3pPr>
            <a:lvl4pPr marL="1242121" indent="0">
              <a:buNone/>
              <a:defRPr sz="1449" b="1"/>
            </a:lvl4pPr>
            <a:lvl5pPr marL="1656161" indent="0">
              <a:buNone/>
              <a:defRPr sz="1449" b="1"/>
            </a:lvl5pPr>
            <a:lvl6pPr marL="2070202" indent="0">
              <a:buNone/>
              <a:defRPr sz="1449" b="1"/>
            </a:lvl6pPr>
            <a:lvl7pPr marL="2484242" indent="0">
              <a:buNone/>
              <a:defRPr sz="1449" b="1"/>
            </a:lvl7pPr>
            <a:lvl8pPr marL="2898282" indent="0">
              <a:buNone/>
              <a:defRPr sz="1449" b="1"/>
            </a:lvl8pPr>
            <a:lvl9pPr marL="3312323" indent="0">
              <a:buNone/>
              <a:defRPr sz="1449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0357" y="2564223"/>
            <a:ext cx="3502997" cy="3771585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191953" y="1720857"/>
            <a:ext cx="3520249" cy="843365"/>
          </a:xfrm>
        </p:spPr>
        <p:txBody>
          <a:bodyPr anchor="b"/>
          <a:lstStyle>
            <a:lvl1pPr marL="0" indent="0">
              <a:buNone/>
              <a:defRPr sz="2173" b="1"/>
            </a:lvl1pPr>
            <a:lvl2pPr marL="414040" indent="0">
              <a:buNone/>
              <a:defRPr sz="1811" b="1"/>
            </a:lvl2pPr>
            <a:lvl3pPr marL="828081" indent="0">
              <a:buNone/>
              <a:defRPr sz="1630" b="1"/>
            </a:lvl3pPr>
            <a:lvl4pPr marL="1242121" indent="0">
              <a:buNone/>
              <a:defRPr sz="1449" b="1"/>
            </a:lvl4pPr>
            <a:lvl5pPr marL="1656161" indent="0">
              <a:buNone/>
              <a:defRPr sz="1449" b="1"/>
            </a:lvl5pPr>
            <a:lvl6pPr marL="2070202" indent="0">
              <a:buNone/>
              <a:defRPr sz="1449" b="1"/>
            </a:lvl6pPr>
            <a:lvl7pPr marL="2484242" indent="0">
              <a:buNone/>
              <a:defRPr sz="1449" b="1"/>
            </a:lvl7pPr>
            <a:lvl8pPr marL="2898282" indent="0">
              <a:buNone/>
              <a:defRPr sz="1449" b="1"/>
            </a:lvl8pPr>
            <a:lvl9pPr marL="3312323" indent="0">
              <a:buNone/>
              <a:defRPr sz="1449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191953" y="2564223"/>
            <a:ext cx="3520249" cy="3771585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31514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08954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5973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467995"/>
            <a:ext cx="2670645" cy="1637983"/>
          </a:xfrm>
        </p:spPr>
        <p:txBody>
          <a:bodyPr anchor="b"/>
          <a:lstStyle>
            <a:lvl1pPr>
              <a:defRPr sz="289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0248" y="1010741"/>
            <a:ext cx="4191953" cy="4988697"/>
          </a:xfrm>
        </p:spPr>
        <p:txBody>
          <a:bodyPr/>
          <a:lstStyle>
            <a:lvl1pPr>
              <a:defRPr sz="2898"/>
            </a:lvl1pPr>
            <a:lvl2pPr>
              <a:defRPr sz="2536"/>
            </a:lvl2pPr>
            <a:lvl3pPr>
              <a:defRPr sz="2173"/>
            </a:lvl3pPr>
            <a:lvl4pPr>
              <a:defRPr sz="1811"/>
            </a:lvl4pPr>
            <a:lvl5pPr>
              <a:defRPr sz="1811"/>
            </a:lvl5pPr>
            <a:lvl6pPr>
              <a:defRPr sz="1811"/>
            </a:lvl6pPr>
            <a:lvl7pPr>
              <a:defRPr sz="1811"/>
            </a:lvl7pPr>
            <a:lvl8pPr>
              <a:defRPr sz="1811"/>
            </a:lvl8pPr>
            <a:lvl9pPr>
              <a:defRPr sz="1811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2105977"/>
            <a:ext cx="2670645" cy="3901584"/>
          </a:xfrm>
        </p:spPr>
        <p:txBody>
          <a:bodyPr/>
          <a:lstStyle>
            <a:lvl1pPr marL="0" indent="0">
              <a:buNone/>
              <a:defRPr sz="1449"/>
            </a:lvl1pPr>
            <a:lvl2pPr marL="414040" indent="0">
              <a:buNone/>
              <a:defRPr sz="1268"/>
            </a:lvl2pPr>
            <a:lvl3pPr marL="828081" indent="0">
              <a:buNone/>
              <a:defRPr sz="1087"/>
            </a:lvl3pPr>
            <a:lvl4pPr marL="1242121" indent="0">
              <a:buNone/>
              <a:defRPr sz="906"/>
            </a:lvl4pPr>
            <a:lvl5pPr marL="1656161" indent="0">
              <a:buNone/>
              <a:defRPr sz="906"/>
            </a:lvl5pPr>
            <a:lvl6pPr marL="2070202" indent="0">
              <a:buNone/>
              <a:defRPr sz="906"/>
            </a:lvl6pPr>
            <a:lvl7pPr marL="2484242" indent="0">
              <a:buNone/>
              <a:defRPr sz="906"/>
            </a:lvl7pPr>
            <a:lvl8pPr marL="2898282" indent="0">
              <a:buNone/>
              <a:defRPr sz="906"/>
            </a:lvl8pPr>
            <a:lvl9pPr marL="3312323" indent="0">
              <a:buNone/>
              <a:defRPr sz="906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31136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70356" y="467995"/>
            <a:ext cx="2670645" cy="1637983"/>
          </a:xfrm>
        </p:spPr>
        <p:txBody>
          <a:bodyPr anchor="b"/>
          <a:lstStyle>
            <a:lvl1pPr>
              <a:defRPr sz="2898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20248" y="1010741"/>
            <a:ext cx="4191953" cy="4988697"/>
          </a:xfrm>
        </p:spPr>
        <p:txBody>
          <a:bodyPr anchor="t"/>
          <a:lstStyle>
            <a:lvl1pPr marL="0" indent="0">
              <a:buNone/>
              <a:defRPr sz="2898"/>
            </a:lvl1pPr>
            <a:lvl2pPr marL="414040" indent="0">
              <a:buNone/>
              <a:defRPr sz="2536"/>
            </a:lvl2pPr>
            <a:lvl3pPr marL="828081" indent="0">
              <a:buNone/>
              <a:defRPr sz="2173"/>
            </a:lvl3pPr>
            <a:lvl4pPr marL="1242121" indent="0">
              <a:buNone/>
              <a:defRPr sz="1811"/>
            </a:lvl4pPr>
            <a:lvl5pPr marL="1656161" indent="0">
              <a:buNone/>
              <a:defRPr sz="1811"/>
            </a:lvl5pPr>
            <a:lvl6pPr marL="2070202" indent="0">
              <a:buNone/>
              <a:defRPr sz="1811"/>
            </a:lvl6pPr>
            <a:lvl7pPr marL="2484242" indent="0">
              <a:buNone/>
              <a:defRPr sz="1811"/>
            </a:lvl7pPr>
            <a:lvl8pPr marL="2898282" indent="0">
              <a:buNone/>
              <a:defRPr sz="1811"/>
            </a:lvl8pPr>
            <a:lvl9pPr marL="3312323" indent="0">
              <a:buNone/>
              <a:defRPr sz="1811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70356" y="2105977"/>
            <a:ext cx="2670645" cy="3901584"/>
          </a:xfrm>
        </p:spPr>
        <p:txBody>
          <a:bodyPr/>
          <a:lstStyle>
            <a:lvl1pPr marL="0" indent="0">
              <a:buNone/>
              <a:defRPr sz="1449"/>
            </a:lvl1pPr>
            <a:lvl2pPr marL="414040" indent="0">
              <a:buNone/>
              <a:defRPr sz="1268"/>
            </a:lvl2pPr>
            <a:lvl3pPr marL="828081" indent="0">
              <a:buNone/>
              <a:defRPr sz="1087"/>
            </a:lvl3pPr>
            <a:lvl4pPr marL="1242121" indent="0">
              <a:buNone/>
              <a:defRPr sz="906"/>
            </a:lvl4pPr>
            <a:lvl5pPr marL="1656161" indent="0">
              <a:buNone/>
              <a:defRPr sz="906"/>
            </a:lvl5pPr>
            <a:lvl6pPr marL="2070202" indent="0">
              <a:buNone/>
              <a:defRPr sz="906"/>
            </a:lvl6pPr>
            <a:lvl7pPr marL="2484242" indent="0">
              <a:buNone/>
              <a:defRPr sz="906"/>
            </a:lvl7pPr>
            <a:lvl8pPr marL="2898282" indent="0">
              <a:buNone/>
              <a:defRPr sz="906"/>
            </a:lvl8pPr>
            <a:lvl9pPr marL="3312323" indent="0">
              <a:buNone/>
              <a:defRPr sz="906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902812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69278" y="373748"/>
            <a:ext cx="7141845" cy="135686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69278" y="1868730"/>
            <a:ext cx="7141845" cy="445407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69278" y="6506432"/>
            <a:ext cx="1863090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ABD615-A9D3-4CA0-B8FA-65AAE081568A}" type="datetimeFigureOut">
              <a:rPr lang="es-ES" smtClean="0"/>
              <a:t>20/09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742883" y="6506432"/>
            <a:ext cx="2794635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848033" y="6506432"/>
            <a:ext cx="1863090" cy="37374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8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46072B-DDC9-4965-BDB0-E178A9AB266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94472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93" r:id="rId1"/>
    <p:sldLayoutId id="2147483794" r:id="rId2"/>
    <p:sldLayoutId id="2147483795" r:id="rId3"/>
    <p:sldLayoutId id="2147483796" r:id="rId4"/>
    <p:sldLayoutId id="2147483797" r:id="rId5"/>
    <p:sldLayoutId id="2147483798" r:id="rId6"/>
    <p:sldLayoutId id="2147483799" r:id="rId7"/>
    <p:sldLayoutId id="2147483800" r:id="rId8"/>
    <p:sldLayoutId id="2147483801" r:id="rId9"/>
    <p:sldLayoutId id="2147483802" r:id="rId10"/>
    <p:sldLayoutId id="2147483803" r:id="rId11"/>
  </p:sldLayoutIdLst>
  <p:txStyles>
    <p:titleStyle>
      <a:lvl1pPr algn="l" defTabSz="828081" rtl="0" eaLnBrk="1" latinLnBrk="0" hangingPunct="1">
        <a:lnSpc>
          <a:spcPct val="90000"/>
        </a:lnSpc>
        <a:spcBef>
          <a:spcPct val="0"/>
        </a:spcBef>
        <a:buNone/>
        <a:defRPr sz="398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07020" indent="-207020" algn="l" defTabSz="828081" rtl="0" eaLnBrk="1" latinLnBrk="0" hangingPunct="1">
        <a:lnSpc>
          <a:spcPct val="90000"/>
        </a:lnSpc>
        <a:spcBef>
          <a:spcPts val="906"/>
        </a:spcBef>
        <a:buFont typeface="Arial" panose="020B0604020202020204" pitchFamily="34" charset="0"/>
        <a:buChar char="•"/>
        <a:defRPr sz="2536" kern="1200">
          <a:solidFill>
            <a:schemeClr val="tx1"/>
          </a:solidFill>
          <a:latin typeface="+mn-lt"/>
          <a:ea typeface="+mn-ea"/>
          <a:cs typeface="+mn-cs"/>
        </a:defRPr>
      </a:lvl1pPr>
      <a:lvl2pPr marL="621060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2pPr>
      <a:lvl3pPr marL="103510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811" kern="1200">
          <a:solidFill>
            <a:schemeClr val="tx1"/>
          </a:solidFill>
          <a:latin typeface="+mn-lt"/>
          <a:ea typeface="+mn-ea"/>
          <a:cs typeface="+mn-cs"/>
        </a:defRPr>
      </a:lvl3pPr>
      <a:lvl4pPr marL="144914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4pPr>
      <a:lvl5pPr marL="1863181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5pPr>
      <a:lvl6pPr marL="227722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6pPr>
      <a:lvl7pPr marL="269126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7pPr>
      <a:lvl8pPr marL="3105302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8pPr>
      <a:lvl9pPr marL="3519343" indent="-207020" algn="l" defTabSz="828081" rtl="0" eaLnBrk="1" latinLnBrk="0" hangingPunct="1">
        <a:lnSpc>
          <a:spcPct val="90000"/>
        </a:lnSpc>
        <a:spcBef>
          <a:spcPts val="453"/>
        </a:spcBef>
        <a:buFont typeface="Arial" panose="020B0604020202020204" pitchFamily="34" charset="0"/>
        <a:buChar char="•"/>
        <a:defRPr sz="16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1pPr>
      <a:lvl2pPr marL="414040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2pPr>
      <a:lvl3pPr marL="82808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3pPr>
      <a:lvl4pPr marL="124212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4pPr>
      <a:lvl5pPr marL="1656161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5pPr>
      <a:lvl6pPr marL="207020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6pPr>
      <a:lvl7pPr marL="248424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7pPr>
      <a:lvl8pPr marL="2898282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8pPr>
      <a:lvl9pPr marL="3312323" algn="l" defTabSz="828081" rtl="0" eaLnBrk="1" latinLnBrk="0" hangingPunct="1">
        <a:defRPr sz="16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9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2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4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27.png"/><Relationship Id="rId4" Type="http://schemas.openxmlformats.org/officeDocument/2006/relationships/image" Target="../media/image2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n 5">
            <a:extLst>
              <a:ext uri="{FF2B5EF4-FFF2-40B4-BE49-F238E27FC236}">
                <a16:creationId xmlns:a16="http://schemas.microsoft.com/office/drawing/2014/main" xmlns="" id="{FB9AFECC-5FF5-4F45-BB8E-AEEE7D67A1C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500" t="29684" r="48060" b="8956"/>
          <a:stretch/>
        </p:blipFill>
        <p:spPr>
          <a:xfrm>
            <a:off x="1183523" y="2081761"/>
            <a:ext cx="5648325" cy="2632092"/>
          </a:xfrm>
          <a:prstGeom prst="rect">
            <a:avLst/>
          </a:prstGeom>
        </p:spPr>
      </p:pic>
      <p:pic>
        <p:nvPicPr>
          <p:cNvPr id="4" name="Marcador de contenido 3"/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6202" t="45433" r="75359" b="44832"/>
          <a:stretch/>
        </p:blipFill>
        <p:spPr>
          <a:xfrm>
            <a:off x="4929597" y="1113065"/>
            <a:ext cx="2969287" cy="766081"/>
          </a:xfrm>
          <a:prstGeom prst="rect">
            <a:avLst/>
          </a:prstGeom>
        </p:spPr>
      </p:pic>
      <p:pic>
        <p:nvPicPr>
          <p:cNvPr id="5" name="Imagen 4"/>
          <p:cNvPicPr>
            <a:picLocks noChangeAspect="1"/>
          </p:cNvPicPr>
          <p:nvPr/>
        </p:nvPicPr>
        <p:blipFill rotWithShape="1">
          <a:blip r:embed="rId4"/>
          <a:srcRect l="20586" t="43127" r="27648" b="34196"/>
          <a:stretch/>
        </p:blipFill>
        <p:spPr>
          <a:xfrm>
            <a:off x="873462" y="5139442"/>
            <a:ext cx="4817513" cy="1187131"/>
          </a:xfrm>
          <a:prstGeom prst="rect">
            <a:avLst/>
          </a:prstGeom>
        </p:spPr>
      </p:pic>
      <p:sp>
        <p:nvSpPr>
          <p:cNvPr id="7" name="Título 1">
            <a:extLst>
              <a:ext uri="{FF2B5EF4-FFF2-40B4-BE49-F238E27FC236}">
                <a16:creationId xmlns:a16="http://schemas.microsoft.com/office/drawing/2014/main" xmlns="" id="{9137D94B-09CB-8F9F-1C90-ED009B8E8182}"/>
              </a:ext>
            </a:extLst>
          </p:cNvPr>
          <p:cNvSpPr txBox="1">
            <a:spLocks/>
          </p:cNvSpPr>
          <p:nvPr/>
        </p:nvSpPr>
        <p:spPr>
          <a:xfrm>
            <a:off x="181775" y="1084502"/>
            <a:ext cx="4747820" cy="491901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/>
              <a:t/>
            </a:r>
            <a:br>
              <a:rPr lang="en-US" sz="1600" b="1" dirty="0"/>
            </a:br>
            <a:r>
              <a:rPr lang="en-US" sz="1600" b="1" dirty="0"/>
              <a:t>1- Locus Chr07g00585341. Putative protein kinase </a:t>
            </a:r>
          </a:p>
          <a:p>
            <a:r>
              <a:rPr lang="en-US" sz="1600" b="1" dirty="0"/>
              <a:t>RLK-Pelle-RLCK-VIIa-2 family</a:t>
            </a:r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xmlns="" id="{99E40E4C-A480-4EE7-A5B1-9C401227122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1446" t="21438" r="76188" b="72532"/>
          <a:stretch/>
        </p:blipFill>
        <p:spPr>
          <a:xfrm>
            <a:off x="7056759" y="1650125"/>
            <a:ext cx="793698" cy="108834"/>
          </a:xfrm>
          <a:prstGeom prst="rect">
            <a:avLst/>
          </a:prstGeom>
        </p:spPr>
      </p:pic>
      <p:sp>
        <p:nvSpPr>
          <p:cNvPr id="11" name="Rectángulo 10">
            <a:extLst>
              <a:ext uri="{FF2B5EF4-FFF2-40B4-BE49-F238E27FC236}">
                <a16:creationId xmlns:a16="http://schemas.microsoft.com/office/drawing/2014/main" xmlns="" id="{78818D85-BC43-4052-AD59-552493F6D843}"/>
              </a:ext>
            </a:extLst>
          </p:cNvPr>
          <p:cNvSpPr/>
          <p:nvPr/>
        </p:nvSpPr>
        <p:spPr>
          <a:xfrm>
            <a:off x="4929597" y="99226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8" name="Rectángulo 7">
            <a:extLst>
              <a:ext uri="{FF2B5EF4-FFF2-40B4-BE49-F238E27FC236}">
                <a16:creationId xmlns:a16="http://schemas.microsoft.com/office/drawing/2014/main" xmlns="" id="{52FBCA7B-6EE0-46CA-B2EB-B8B104E62265}"/>
              </a:ext>
            </a:extLst>
          </p:cNvPr>
          <p:cNvSpPr/>
          <p:nvPr/>
        </p:nvSpPr>
        <p:spPr>
          <a:xfrm>
            <a:off x="5031147" y="851893"/>
            <a:ext cx="1948775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938823"/>
            <a:ext cx="5690134" cy="28049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" name="Rectángulo 1">
            <a:extLst>
              <a:ext uri="{FF2B5EF4-FFF2-40B4-BE49-F238E27FC236}">
                <a16:creationId xmlns:a16="http://schemas.microsoft.com/office/drawing/2014/main" xmlns="" id="{38EDA277-4088-4E01-854D-5FBCC4B852D6}"/>
              </a:ext>
            </a:extLst>
          </p:cNvPr>
          <p:cNvSpPr/>
          <p:nvPr/>
        </p:nvSpPr>
        <p:spPr>
          <a:xfrm>
            <a:off x="1239285" y="1836221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4909145"/>
            <a:ext cx="5690134" cy="19024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0" name="Rectángulo 9">
            <a:extLst>
              <a:ext uri="{FF2B5EF4-FFF2-40B4-BE49-F238E27FC236}">
                <a16:creationId xmlns:a16="http://schemas.microsoft.com/office/drawing/2014/main" xmlns="" id="{0ABDA196-0729-4117-95F9-A8E1D08D13CB}"/>
              </a:ext>
            </a:extLst>
          </p:cNvPr>
          <p:cNvSpPr/>
          <p:nvPr/>
        </p:nvSpPr>
        <p:spPr>
          <a:xfrm>
            <a:off x="1239287" y="4779470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33</a:t>
            </a:r>
            <a:r>
              <a:rPr lang="en-US" sz="1200" b="1" dirty="0"/>
              <a:t>)</a:t>
            </a:r>
            <a:endParaRPr lang="es-ES" sz="1200" dirty="0"/>
          </a:p>
        </p:txBody>
      </p:sp>
      <p:pic>
        <p:nvPicPr>
          <p:cNvPr id="14" name="Imagen 13">
            <a:extLst>
              <a:ext uri="{FF2B5EF4-FFF2-40B4-BE49-F238E27FC236}">
                <a16:creationId xmlns:a16="http://schemas.microsoft.com/office/drawing/2014/main" xmlns="" id="{6BC5F06B-F23B-4EA7-9DBF-78EC6DD52C3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966" t="79693" r="34104" b="17770"/>
          <a:stretch/>
        </p:blipFill>
        <p:spPr>
          <a:xfrm>
            <a:off x="2517579" y="6491966"/>
            <a:ext cx="4229642" cy="163458"/>
          </a:xfrm>
          <a:prstGeom prst="rect">
            <a:avLst/>
          </a:prstGeom>
        </p:spPr>
      </p:pic>
      <p:sp>
        <p:nvSpPr>
          <p:cNvPr id="15" name="5 Rectángulo">
            <a:extLst>
              <a:ext uri="{FF2B5EF4-FFF2-40B4-BE49-F238E27FC236}">
                <a16:creationId xmlns:a16="http://schemas.microsoft.com/office/drawing/2014/main" xmlns="" id="{A7ED45F8-1305-49FB-BE66-E106133BE7D1}"/>
              </a:ext>
            </a:extLst>
          </p:cNvPr>
          <p:cNvSpPr/>
          <p:nvPr/>
        </p:nvSpPr>
        <p:spPr>
          <a:xfrm>
            <a:off x="112140" y="66262"/>
            <a:ext cx="7919499" cy="738664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sz="1600" b="1" u="sng" dirty="0" smtClean="0">
                <a:latin typeface="+mj-lt"/>
              </a:rPr>
              <a:t>Figure S2</a:t>
            </a:r>
            <a:r>
              <a:rPr lang="en-US" sz="1600" b="1" dirty="0">
                <a:latin typeface="+mj-lt"/>
              </a:rPr>
              <a:t>. </a:t>
            </a:r>
            <a:r>
              <a:rPr lang="en-US" sz="1600" b="1" dirty="0" err="1">
                <a:latin typeface="+mj-lt"/>
              </a:rPr>
              <a:t>InterPro</a:t>
            </a:r>
            <a:r>
              <a:rPr lang="en-US" sz="1600" b="1" dirty="0">
                <a:latin typeface="+mj-lt"/>
              </a:rPr>
              <a:t> and </a:t>
            </a:r>
            <a:r>
              <a:rPr lang="en-US" sz="1600" b="1" dirty="0" err="1">
                <a:latin typeface="+mj-lt"/>
              </a:rPr>
              <a:t>ProSite</a:t>
            </a:r>
            <a:r>
              <a:rPr lang="en-US" sz="1600" b="1" dirty="0">
                <a:latin typeface="+mj-lt"/>
              </a:rPr>
              <a:t> domain constitution of putative protein kinase genes in the Iasnip-40 to Iasnip-105 </a:t>
            </a:r>
            <a:r>
              <a:rPr lang="en-US" sz="1600" b="1" i="1" dirty="0">
                <a:latin typeface="+mj-lt"/>
              </a:rPr>
              <a:t>Or</a:t>
            </a:r>
            <a:r>
              <a:rPr lang="en-US" sz="1600" b="1" i="1" baseline="-25000" dirty="0">
                <a:latin typeface="+mj-lt"/>
              </a:rPr>
              <a:t>Anom1</a:t>
            </a:r>
            <a:r>
              <a:rPr lang="en-US" sz="1600" b="1" dirty="0">
                <a:latin typeface="+mj-lt"/>
              </a:rPr>
              <a:t> region from the chromosome assembled genome sequence of </a:t>
            </a:r>
            <a:r>
              <a:rPr lang="en-US" sz="1600" b="1" i="1" dirty="0">
                <a:latin typeface="+mj-lt"/>
              </a:rPr>
              <a:t>H. </a:t>
            </a:r>
            <a:r>
              <a:rPr lang="en-US" sz="1600" b="1" i="1" dirty="0" err="1">
                <a:latin typeface="+mj-lt"/>
              </a:rPr>
              <a:t>anomalus</a:t>
            </a:r>
            <a:r>
              <a:rPr lang="en-US" sz="1600" b="1" dirty="0">
                <a:latin typeface="+mj-lt"/>
              </a:rPr>
              <a:t> (HanomANO2822-UBC). TAIR </a:t>
            </a:r>
            <a:r>
              <a:rPr lang="en-US" sz="1600" b="1" dirty="0" err="1">
                <a:latin typeface="+mj-lt"/>
              </a:rPr>
              <a:t>BlastP</a:t>
            </a:r>
            <a:r>
              <a:rPr lang="en-US" sz="1600" b="1" dirty="0">
                <a:latin typeface="+mj-lt"/>
              </a:rPr>
              <a:t> analyses are also shown. </a:t>
            </a:r>
            <a:endParaRPr lang="en-US" sz="1600" b="1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87871320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533959"/>
            <a:ext cx="5690134" cy="180711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3801739"/>
            <a:ext cx="5690134" cy="180711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966" t="79693" r="34104" b="17770"/>
          <a:stretch/>
        </p:blipFill>
        <p:spPr>
          <a:xfrm>
            <a:off x="2486898" y="5149031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239287" y="3672063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10</a:t>
            </a:r>
            <a:r>
              <a:rPr lang="en-US" sz="1200" b="1" dirty="0"/>
              <a:t>)</a:t>
            </a:r>
            <a:endParaRPr lang="es-ES" sz="1200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xmlns="" id="{E64B1294-97A2-4D58-8A42-25882A346E1F}"/>
              </a:ext>
            </a:extLst>
          </p:cNvPr>
          <p:cNvSpPr/>
          <p:nvPr/>
        </p:nvSpPr>
        <p:spPr>
          <a:xfrm>
            <a:off x="1239285" y="1431357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xmlns="" id="{DB49988B-5E72-48A0-A313-58B31E93668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644" t="52110" r="27440" b="30716"/>
          <a:stretch/>
        </p:blipFill>
        <p:spPr>
          <a:xfrm>
            <a:off x="1239285" y="4078738"/>
            <a:ext cx="4693484" cy="908343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321C4563-D930-4BD7-9301-C2CEC39A437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167" t="45413" r="18910" b="27817"/>
          <a:stretch/>
        </p:blipFill>
        <p:spPr>
          <a:xfrm>
            <a:off x="1239287" y="2011744"/>
            <a:ext cx="5293129" cy="1246909"/>
          </a:xfrm>
          <a:prstGeom prst="rect">
            <a:avLst/>
          </a:prstGeom>
        </p:spPr>
      </p:pic>
      <p:sp>
        <p:nvSpPr>
          <p:cNvPr id="10" name="Título 1">
            <a:extLst>
              <a:ext uri="{FF2B5EF4-FFF2-40B4-BE49-F238E27FC236}">
                <a16:creationId xmlns:a16="http://schemas.microsoft.com/office/drawing/2014/main" xmlns="" id="{64235053-FA5B-4DF3-8099-F6FCBEEB8B33}"/>
              </a:ext>
            </a:extLst>
          </p:cNvPr>
          <p:cNvSpPr txBox="1">
            <a:spLocks/>
          </p:cNvSpPr>
          <p:nvPr/>
        </p:nvSpPr>
        <p:spPr>
          <a:xfrm>
            <a:off x="479230" y="905053"/>
            <a:ext cx="7442460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10- Locus Chr07g00585851. </a:t>
            </a:r>
            <a:r>
              <a:rPr lang="es-ES" b="1" dirty="0" err="1"/>
              <a:t>Putative</a:t>
            </a:r>
            <a:r>
              <a:rPr lang="es-ES" b="1" dirty="0"/>
              <a:t> non-</a:t>
            </a:r>
            <a:r>
              <a:rPr lang="es-ES" b="1" dirty="0" err="1"/>
              <a:t>specific</a:t>
            </a:r>
            <a:r>
              <a:rPr lang="es-ES" b="1" dirty="0"/>
              <a:t> </a:t>
            </a:r>
            <a:r>
              <a:rPr lang="es-ES" b="1" dirty="0" err="1"/>
              <a:t>serine</a:t>
            </a:r>
            <a:r>
              <a:rPr lang="es-ES" b="1" dirty="0"/>
              <a:t>/</a:t>
            </a:r>
            <a:r>
              <a:rPr lang="es-ES" b="1" dirty="0" err="1"/>
              <a:t>threonine</a:t>
            </a:r>
            <a:r>
              <a:rPr lang="es-ES" b="1" dirty="0"/>
              <a:t> </a:t>
            </a:r>
            <a:r>
              <a:rPr lang="es-ES" b="1" dirty="0" err="1"/>
              <a:t>protein</a:t>
            </a:r>
            <a:r>
              <a:rPr lang="es-ES" b="1" dirty="0"/>
              <a:t> </a:t>
            </a:r>
            <a:r>
              <a:rPr lang="es-ES" b="1" dirty="0" err="1"/>
              <a:t>kinase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38295550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Imagen 20">
            <a:extLst>
              <a:ext uri="{FF2B5EF4-FFF2-40B4-BE49-F238E27FC236}">
                <a16:creationId xmlns:a16="http://schemas.microsoft.com/office/drawing/2014/main" xmlns="" id="{579327A9-9342-4BB2-9AAC-9629468192A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876" t="35376" r="48776" b="25991"/>
          <a:stretch/>
        </p:blipFill>
        <p:spPr>
          <a:xfrm>
            <a:off x="1254109" y="1699683"/>
            <a:ext cx="5577739" cy="1639887"/>
          </a:xfrm>
          <a:prstGeom prst="rect">
            <a:avLst/>
          </a:prstGeom>
        </p:spPr>
      </p:pic>
      <p:pic>
        <p:nvPicPr>
          <p:cNvPr id="19" name="Marcador de contenido 4">
            <a:extLst>
              <a:ext uri="{FF2B5EF4-FFF2-40B4-BE49-F238E27FC236}">
                <a16:creationId xmlns:a16="http://schemas.microsoft.com/office/drawing/2014/main" xmlns="" id="{D01AC991-3984-40CB-A8C1-375EB6A1292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79" t="53492" r="89064" b="36350"/>
          <a:stretch/>
        </p:blipFill>
        <p:spPr>
          <a:xfrm>
            <a:off x="6059863" y="601424"/>
            <a:ext cx="730175" cy="656866"/>
          </a:xfrm>
          <a:prstGeom prst="rect">
            <a:avLst/>
          </a:prstGeom>
        </p:spPr>
      </p:pic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459316"/>
            <a:ext cx="5690134" cy="21710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3851141"/>
            <a:ext cx="5690134" cy="15383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966" t="79693" r="34104" b="17770"/>
          <a:stretch/>
        </p:blipFill>
        <p:spPr>
          <a:xfrm>
            <a:off x="2465126" y="5114770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239287" y="3721465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18</a:t>
            </a:r>
            <a:r>
              <a:rPr lang="en-US" sz="1200" b="1" dirty="0"/>
              <a:t>)</a:t>
            </a:r>
            <a:endParaRPr lang="es-ES" sz="1200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xmlns="" id="{E64B1294-97A2-4D58-8A42-25882A346E1F}"/>
              </a:ext>
            </a:extLst>
          </p:cNvPr>
          <p:cNvSpPr/>
          <p:nvPr/>
        </p:nvSpPr>
        <p:spPr>
          <a:xfrm>
            <a:off x="1239285" y="1356714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20" name="Imagen 19">
            <a:extLst>
              <a:ext uri="{FF2B5EF4-FFF2-40B4-BE49-F238E27FC236}">
                <a16:creationId xmlns:a16="http://schemas.microsoft.com/office/drawing/2014/main" xmlns="" id="{3A61935A-2D78-45FA-B9D8-F728B2FDB92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976" t="51989" r="27546" b="29338"/>
          <a:stretch/>
        </p:blipFill>
        <p:spPr>
          <a:xfrm>
            <a:off x="1179814" y="3998464"/>
            <a:ext cx="4563763" cy="968855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179BC9AB-E058-4CF7-8BD4-9E832DCF1E6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446" t="21438" r="76188" b="72532"/>
          <a:stretch/>
        </p:blipFill>
        <p:spPr>
          <a:xfrm>
            <a:off x="7411765" y="1211198"/>
            <a:ext cx="686863" cy="94184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xmlns="" id="{BFCD14F6-98FB-4E6F-9243-257ECCC9EC58}"/>
              </a:ext>
            </a:extLst>
          </p:cNvPr>
          <p:cNvSpPr/>
          <p:nvPr/>
        </p:nvSpPr>
        <p:spPr>
          <a:xfrm>
            <a:off x="4929597" y="57029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xmlns="" id="{34C223AE-3AC1-4890-A2DE-704F896B88A4}"/>
              </a:ext>
            </a:extLst>
          </p:cNvPr>
          <p:cNvSpPr/>
          <p:nvPr/>
        </p:nvSpPr>
        <p:spPr>
          <a:xfrm>
            <a:off x="5031147" y="385533"/>
            <a:ext cx="2107543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24" name="Título 1">
            <a:extLst>
              <a:ext uri="{FF2B5EF4-FFF2-40B4-BE49-F238E27FC236}">
                <a16:creationId xmlns:a16="http://schemas.microsoft.com/office/drawing/2014/main" xmlns="" id="{60F475C9-4D49-4950-B5D4-82F5C78626BC}"/>
              </a:ext>
            </a:extLst>
          </p:cNvPr>
          <p:cNvSpPr txBox="1">
            <a:spLocks/>
          </p:cNvSpPr>
          <p:nvPr/>
        </p:nvSpPr>
        <p:spPr>
          <a:xfrm>
            <a:off x="479230" y="905053"/>
            <a:ext cx="4252496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11- Locus Chr07g00585861. Putative protein kinase RLK-Pelle-RLCK-VIIa-2 family</a:t>
            </a:r>
          </a:p>
        </p:txBody>
      </p:sp>
    </p:spTree>
    <p:extLst>
      <p:ext uri="{BB962C8B-B14F-4D97-AF65-F5344CB8AC3E}">
        <p14:creationId xmlns:p14="http://schemas.microsoft.com/office/powerpoint/2010/main" val="6839190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n 15">
            <a:extLst>
              <a:ext uri="{FF2B5EF4-FFF2-40B4-BE49-F238E27FC236}">
                <a16:creationId xmlns:a16="http://schemas.microsoft.com/office/drawing/2014/main" xmlns="" id="{E550126C-BC35-4F2D-8F83-58E5443231F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734" t="38346" r="85870" b="53646"/>
          <a:stretch/>
        </p:blipFill>
        <p:spPr>
          <a:xfrm>
            <a:off x="5521092" y="746472"/>
            <a:ext cx="1367388" cy="570257"/>
          </a:xfrm>
          <a:prstGeom prst="rect">
            <a:avLst/>
          </a:prstGeom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xmlns="" id="{99E40E4C-A480-4EE7-A5B1-9C401227122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446" t="21438" r="76188" b="72532"/>
          <a:stretch/>
        </p:blipFill>
        <p:spPr>
          <a:xfrm>
            <a:off x="7355445" y="1204871"/>
            <a:ext cx="686863" cy="94184"/>
          </a:xfrm>
          <a:prstGeom prst="rect">
            <a:avLst/>
          </a:prstGeom>
        </p:spPr>
      </p:pic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554178"/>
            <a:ext cx="5690134" cy="28049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4524501"/>
            <a:ext cx="5690134" cy="16195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8966" t="79693" r="34104" b="17770"/>
          <a:stretch/>
        </p:blipFill>
        <p:spPr>
          <a:xfrm>
            <a:off x="2226373" y="5813866"/>
            <a:ext cx="4229642" cy="163458"/>
          </a:xfrm>
          <a:prstGeom prst="rect">
            <a:avLst/>
          </a:prstGeom>
        </p:spPr>
      </p:pic>
      <p:pic>
        <p:nvPicPr>
          <p:cNvPr id="17" name="Marcador de contenido 5">
            <a:extLst>
              <a:ext uri="{FF2B5EF4-FFF2-40B4-BE49-F238E27FC236}">
                <a16:creationId xmlns:a16="http://schemas.microsoft.com/office/drawing/2014/main" xmlns="" id="{0B3332EC-46BA-482F-BA56-EE454FEE6E7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2338" t="42757" r="27706" b="32745"/>
          <a:stretch/>
        </p:blipFill>
        <p:spPr>
          <a:xfrm>
            <a:off x="1183155" y="4671824"/>
            <a:ext cx="4198127" cy="1158087"/>
          </a:xfrm>
          <a:prstGeom prst="rect">
            <a:avLst/>
          </a:prstGeom>
        </p:spPr>
      </p:pic>
      <p:sp>
        <p:nvSpPr>
          <p:cNvPr id="20" name="Rectángulo 19">
            <a:extLst>
              <a:ext uri="{FF2B5EF4-FFF2-40B4-BE49-F238E27FC236}">
                <a16:creationId xmlns:a16="http://schemas.microsoft.com/office/drawing/2014/main" xmlns="" id="{4DE9F8F9-8BDE-471F-A673-7D018B9B699A}"/>
              </a:ext>
            </a:extLst>
          </p:cNvPr>
          <p:cNvSpPr/>
          <p:nvPr/>
        </p:nvSpPr>
        <p:spPr>
          <a:xfrm>
            <a:off x="1239287" y="4394825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75</a:t>
            </a:r>
            <a:r>
              <a:rPr lang="en-US" sz="1200" b="1" dirty="0"/>
              <a:t>)</a:t>
            </a:r>
            <a:endParaRPr lang="es-ES" sz="1200" dirty="0"/>
          </a:p>
        </p:txBody>
      </p:sp>
      <p:sp>
        <p:nvSpPr>
          <p:cNvPr id="21" name="Rectángulo 20">
            <a:extLst>
              <a:ext uri="{FF2B5EF4-FFF2-40B4-BE49-F238E27FC236}">
                <a16:creationId xmlns:a16="http://schemas.microsoft.com/office/drawing/2014/main" xmlns="" id="{5D8D1D9C-D619-4870-BBE4-59B867C2686C}"/>
              </a:ext>
            </a:extLst>
          </p:cNvPr>
          <p:cNvSpPr/>
          <p:nvPr/>
        </p:nvSpPr>
        <p:spPr>
          <a:xfrm>
            <a:off x="1239285" y="1470238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8D4AF2FD-8F6E-49ED-90D6-7C0EF213CE09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6055" t="26978" r="48799" b="9693"/>
          <a:stretch/>
        </p:blipFill>
        <p:spPr>
          <a:xfrm>
            <a:off x="1448556" y="1769770"/>
            <a:ext cx="4923671" cy="244692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EC84A7C2-CA2D-4DBF-94C8-2388A2B38AC0}"/>
              </a:ext>
            </a:extLst>
          </p:cNvPr>
          <p:cNvSpPr/>
          <p:nvPr/>
        </p:nvSpPr>
        <p:spPr>
          <a:xfrm>
            <a:off x="4929597" y="57029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9" name="Rectángulo 18">
            <a:extLst>
              <a:ext uri="{FF2B5EF4-FFF2-40B4-BE49-F238E27FC236}">
                <a16:creationId xmlns:a16="http://schemas.microsoft.com/office/drawing/2014/main" xmlns="" id="{B3F1584E-402E-413F-9713-5263A39A87B7}"/>
              </a:ext>
            </a:extLst>
          </p:cNvPr>
          <p:cNvSpPr/>
          <p:nvPr/>
        </p:nvSpPr>
        <p:spPr>
          <a:xfrm>
            <a:off x="5031147" y="385533"/>
            <a:ext cx="2107543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22" name="Título 1">
            <a:extLst>
              <a:ext uri="{FF2B5EF4-FFF2-40B4-BE49-F238E27FC236}">
                <a16:creationId xmlns:a16="http://schemas.microsoft.com/office/drawing/2014/main" xmlns="" id="{143A5A0F-6495-414C-AFFE-7928DEC4A9C3}"/>
              </a:ext>
            </a:extLst>
          </p:cNvPr>
          <p:cNvSpPr txBox="1">
            <a:spLocks/>
          </p:cNvSpPr>
          <p:nvPr/>
        </p:nvSpPr>
        <p:spPr>
          <a:xfrm>
            <a:off x="181775" y="905053"/>
            <a:ext cx="4747820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2- Locus Chr07g00585411. Putative protein kinase </a:t>
            </a:r>
          </a:p>
          <a:p>
            <a:r>
              <a:rPr lang="en-US" b="1" dirty="0"/>
              <a:t>RLK-Pelle-RLCK-VIIa-2 family</a:t>
            </a:r>
          </a:p>
        </p:txBody>
      </p:sp>
    </p:spTree>
    <p:extLst>
      <p:ext uri="{BB962C8B-B14F-4D97-AF65-F5344CB8AC3E}">
        <p14:creationId xmlns:p14="http://schemas.microsoft.com/office/powerpoint/2010/main" val="40823035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645924"/>
            <a:ext cx="5690134" cy="28049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4616246"/>
            <a:ext cx="5690134" cy="15168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966" t="79693" r="34104" b="17770"/>
          <a:stretch/>
        </p:blipFill>
        <p:spPr>
          <a:xfrm>
            <a:off x="2472806" y="5897244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239287" y="4486571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28</a:t>
            </a:r>
            <a:r>
              <a:rPr lang="en-US" sz="1200" b="1" dirty="0"/>
              <a:t>)</a:t>
            </a:r>
            <a:endParaRPr lang="es-ES" sz="1200" dirty="0"/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xmlns="" id="{44F6A003-4317-46BC-AAE8-E56D7407BA5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2842" t="52295" r="27890" b="20102"/>
          <a:stretch/>
        </p:blipFill>
        <p:spPr>
          <a:xfrm>
            <a:off x="1614050" y="4726505"/>
            <a:ext cx="3562709" cy="1122793"/>
          </a:xfrm>
          <a:prstGeom prst="rect">
            <a:avLst/>
          </a:prstGeom>
        </p:spPr>
      </p:pic>
      <p:sp>
        <p:nvSpPr>
          <p:cNvPr id="19" name="Rectángulo 18">
            <a:extLst>
              <a:ext uri="{FF2B5EF4-FFF2-40B4-BE49-F238E27FC236}">
                <a16:creationId xmlns:a16="http://schemas.microsoft.com/office/drawing/2014/main" xmlns="" id="{721464CD-1187-4505-A6ED-8A97A5AB784B}"/>
              </a:ext>
            </a:extLst>
          </p:cNvPr>
          <p:cNvSpPr/>
          <p:nvPr/>
        </p:nvSpPr>
        <p:spPr>
          <a:xfrm>
            <a:off x="1239285" y="1543322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34CD4C1D-F949-407D-B3B9-9B2B9DAA45A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157" t="27610" r="18233" b="13762"/>
          <a:stretch/>
        </p:blipFill>
        <p:spPr>
          <a:xfrm>
            <a:off x="1757373" y="1886015"/>
            <a:ext cx="4458812" cy="2465226"/>
          </a:xfrm>
          <a:prstGeom prst="rect">
            <a:avLst/>
          </a:prstGeom>
        </p:spPr>
      </p:pic>
      <p:pic>
        <p:nvPicPr>
          <p:cNvPr id="16" name="Marcador de contenido 5">
            <a:extLst>
              <a:ext uri="{FF2B5EF4-FFF2-40B4-BE49-F238E27FC236}">
                <a16:creationId xmlns:a16="http://schemas.microsoft.com/office/drawing/2014/main" xmlns="" id="{8B31E48A-136F-4240-9911-510C0C0D1D6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5"/>
          <a:srcRect l="7064" t="38188" r="88535" b="53345"/>
          <a:stretch/>
        </p:blipFill>
        <p:spPr>
          <a:xfrm>
            <a:off x="5792914" y="662530"/>
            <a:ext cx="951094" cy="676934"/>
          </a:xfrm>
          <a:prstGeom prst="rect">
            <a:avLst/>
          </a:prstGeom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xmlns="" id="{626F885D-DFE9-4FE5-9539-A38A955512C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446" t="21438" r="76188" b="72532"/>
          <a:stretch/>
        </p:blipFill>
        <p:spPr>
          <a:xfrm>
            <a:off x="7355445" y="1204871"/>
            <a:ext cx="686863" cy="94184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xmlns="" id="{C7B98FBA-4FEF-4CAD-9521-61B05945B7D7}"/>
              </a:ext>
            </a:extLst>
          </p:cNvPr>
          <p:cNvSpPr/>
          <p:nvPr/>
        </p:nvSpPr>
        <p:spPr>
          <a:xfrm>
            <a:off x="4929597" y="57029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xmlns="" id="{1E1D9BA5-CDFB-4D6E-9923-F68C97392426}"/>
              </a:ext>
            </a:extLst>
          </p:cNvPr>
          <p:cNvSpPr/>
          <p:nvPr/>
        </p:nvSpPr>
        <p:spPr>
          <a:xfrm>
            <a:off x="5031147" y="385533"/>
            <a:ext cx="2107543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24" name="Título 1">
            <a:extLst>
              <a:ext uri="{FF2B5EF4-FFF2-40B4-BE49-F238E27FC236}">
                <a16:creationId xmlns:a16="http://schemas.microsoft.com/office/drawing/2014/main" xmlns="" id="{24EEDD6D-6B43-4608-8C4B-A66340FE9D4C}"/>
              </a:ext>
            </a:extLst>
          </p:cNvPr>
          <p:cNvSpPr txBox="1">
            <a:spLocks/>
          </p:cNvSpPr>
          <p:nvPr/>
        </p:nvSpPr>
        <p:spPr>
          <a:xfrm>
            <a:off x="479230" y="905053"/>
            <a:ext cx="4252496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3- Locus Chr07g00585431. </a:t>
            </a:r>
            <a:r>
              <a:rPr lang="es-ES" b="1" dirty="0" err="1"/>
              <a:t>Putative</a:t>
            </a:r>
            <a:r>
              <a:rPr lang="es-ES" b="1" dirty="0"/>
              <a:t> </a:t>
            </a:r>
            <a:r>
              <a:rPr lang="es-ES" b="1" dirty="0" err="1"/>
              <a:t>protein</a:t>
            </a:r>
            <a:r>
              <a:rPr lang="es-ES" b="1" dirty="0"/>
              <a:t> </a:t>
            </a:r>
            <a:r>
              <a:rPr lang="es-ES" b="1" dirty="0" err="1"/>
              <a:t>kinase</a:t>
            </a:r>
            <a:r>
              <a:rPr lang="es-ES" b="1" dirty="0"/>
              <a:t> RLK-Pelle-CrRLK1L-1 </a:t>
            </a:r>
            <a:r>
              <a:rPr lang="es-ES" b="1" dirty="0" err="1"/>
              <a:t>family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9177824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Marcador de contenido 3">
            <a:extLst>
              <a:ext uri="{FF2B5EF4-FFF2-40B4-BE49-F238E27FC236}">
                <a16:creationId xmlns:a16="http://schemas.microsoft.com/office/drawing/2014/main" xmlns="" id="{65CECF8F-3ADF-421E-A6CF-67C33EF2A20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7181" t="47905" r="87733" b="43960"/>
          <a:stretch/>
        </p:blipFill>
        <p:spPr>
          <a:xfrm>
            <a:off x="6014456" y="679137"/>
            <a:ext cx="1056626" cy="674287"/>
          </a:xfrm>
          <a:prstGeom prst="rect">
            <a:avLst/>
          </a:prstGeom>
        </p:spPr>
      </p:pic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550424"/>
            <a:ext cx="5690134" cy="209748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3813300"/>
            <a:ext cx="5690134" cy="198742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966" t="79693" r="34104" b="17770"/>
          <a:stretch/>
        </p:blipFill>
        <p:spPr>
          <a:xfrm>
            <a:off x="2475204" y="5526006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239287" y="3683624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44</a:t>
            </a:r>
            <a:r>
              <a:rPr lang="en-US" sz="1200" b="1" dirty="0"/>
              <a:t>)</a:t>
            </a:r>
            <a:endParaRPr lang="es-ES" sz="1200" dirty="0"/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xmlns="" id="{CF787AE6-6A21-4CE0-A49E-F9FD72F957F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3146" t="52160" r="27804" b="18665"/>
          <a:stretch/>
        </p:blipFill>
        <p:spPr>
          <a:xfrm>
            <a:off x="1239285" y="4043897"/>
            <a:ext cx="4127606" cy="1381041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17693E25-79D6-40BF-ACA9-5B1235A9B67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584" t="34982" r="48777" b="19289"/>
          <a:stretch/>
        </p:blipFill>
        <p:spPr>
          <a:xfrm>
            <a:off x="1579568" y="1820235"/>
            <a:ext cx="4889813" cy="1729323"/>
          </a:xfrm>
          <a:prstGeom prst="rect">
            <a:avLst/>
          </a:prstGeom>
        </p:spPr>
      </p:pic>
      <p:sp>
        <p:nvSpPr>
          <p:cNvPr id="19" name="Rectángulo 18">
            <a:extLst>
              <a:ext uri="{FF2B5EF4-FFF2-40B4-BE49-F238E27FC236}">
                <a16:creationId xmlns:a16="http://schemas.microsoft.com/office/drawing/2014/main" xmlns="" id="{F9B27FB0-C68B-4CCA-B252-2D58A4164164}"/>
              </a:ext>
            </a:extLst>
          </p:cNvPr>
          <p:cNvSpPr/>
          <p:nvPr/>
        </p:nvSpPr>
        <p:spPr>
          <a:xfrm>
            <a:off x="1239285" y="1460664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21" name="Imagen 20">
            <a:extLst>
              <a:ext uri="{FF2B5EF4-FFF2-40B4-BE49-F238E27FC236}">
                <a16:creationId xmlns:a16="http://schemas.microsoft.com/office/drawing/2014/main" xmlns="" id="{0EE0F366-2676-4A24-916A-DD10A4DD060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446" t="21438" r="76188" b="72532"/>
          <a:stretch/>
        </p:blipFill>
        <p:spPr>
          <a:xfrm>
            <a:off x="7355445" y="1204871"/>
            <a:ext cx="686863" cy="94184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xmlns="" id="{024B7A12-13C0-433B-A3FF-F4922AE148F8}"/>
              </a:ext>
            </a:extLst>
          </p:cNvPr>
          <p:cNvSpPr/>
          <p:nvPr/>
        </p:nvSpPr>
        <p:spPr>
          <a:xfrm>
            <a:off x="4929597" y="57029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xmlns="" id="{B6FED0C0-4293-4E92-997E-C92ED010B213}"/>
              </a:ext>
            </a:extLst>
          </p:cNvPr>
          <p:cNvSpPr/>
          <p:nvPr/>
        </p:nvSpPr>
        <p:spPr>
          <a:xfrm>
            <a:off x="5031147" y="385533"/>
            <a:ext cx="2107543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24" name="Título 1">
            <a:extLst>
              <a:ext uri="{FF2B5EF4-FFF2-40B4-BE49-F238E27FC236}">
                <a16:creationId xmlns:a16="http://schemas.microsoft.com/office/drawing/2014/main" xmlns="" id="{B9C54DF5-FC3B-4220-A6F6-15D6F6453660}"/>
              </a:ext>
            </a:extLst>
          </p:cNvPr>
          <p:cNvSpPr txBox="1">
            <a:spLocks/>
          </p:cNvSpPr>
          <p:nvPr/>
        </p:nvSpPr>
        <p:spPr>
          <a:xfrm>
            <a:off x="479230" y="905053"/>
            <a:ext cx="4252496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4- Locus Chr07g0085451. Putative protein kinase RLK-Pelle-RLCK-VIIa-2 family</a:t>
            </a:r>
          </a:p>
        </p:txBody>
      </p:sp>
    </p:spTree>
    <p:extLst>
      <p:ext uri="{BB962C8B-B14F-4D97-AF65-F5344CB8AC3E}">
        <p14:creationId xmlns:p14="http://schemas.microsoft.com/office/powerpoint/2010/main" val="18735639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449985"/>
            <a:ext cx="5690134" cy="20990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3757827"/>
            <a:ext cx="5690134" cy="19065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966" t="79693" r="34104" b="17770"/>
          <a:stretch/>
        </p:blipFill>
        <p:spPr>
          <a:xfrm>
            <a:off x="2477567" y="5408014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239287" y="3628151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25</a:t>
            </a:r>
            <a:r>
              <a:rPr lang="en-US" sz="1200" b="1" dirty="0"/>
              <a:t>)</a:t>
            </a:r>
            <a:endParaRPr lang="es-ES" sz="1200" dirty="0"/>
          </a:p>
        </p:txBody>
      </p:sp>
      <p:pic>
        <p:nvPicPr>
          <p:cNvPr id="17" name="Imagen 16">
            <a:extLst>
              <a:ext uri="{FF2B5EF4-FFF2-40B4-BE49-F238E27FC236}">
                <a16:creationId xmlns:a16="http://schemas.microsoft.com/office/drawing/2014/main" xmlns="" id="{3AA5AB21-C386-43AA-81C3-240F5579B49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3332" t="52322" r="27631" b="20392"/>
          <a:stretch/>
        </p:blipFill>
        <p:spPr>
          <a:xfrm>
            <a:off x="1239285" y="3875914"/>
            <a:ext cx="4377744" cy="1370226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CFA79001-3B75-45B0-A95B-23DA59B39A5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053" t="35227" r="48757" b="26779"/>
          <a:stretch/>
        </p:blipFill>
        <p:spPr>
          <a:xfrm>
            <a:off x="1448555" y="1908793"/>
            <a:ext cx="5383292" cy="1562106"/>
          </a:xfrm>
          <a:prstGeom prst="rect">
            <a:avLst/>
          </a:prstGeom>
        </p:spPr>
      </p:pic>
      <p:sp>
        <p:nvSpPr>
          <p:cNvPr id="19" name="Rectángulo 18">
            <a:extLst>
              <a:ext uri="{FF2B5EF4-FFF2-40B4-BE49-F238E27FC236}">
                <a16:creationId xmlns:a16="http://schemas.microsoft.com/office/drawing/2014/main" xmlns="" id="{E431B99A-58D0-49BF-AFF8-62EA6512FEAE}"/>
              </a:ext>
            </a:extLst>
          </p:cNvPr>
          <p:cNvSpPr/>
          <p:nvPr/>
        </p:nvSpPr>
        <p:spPr>
          <a:xfrm>
            <a:off x="1239285" y="1347383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16" name="Marcador de contenido 4">
            <a:extLst>
              <a:ext uri="{FF2B5EF4-FFF2-40B4-BE49-F238E27FC236}">
                <a16:creationId xmlns:a16="http://schemas.microsoft.com/office/drawing/2014/main" xmlns="" id="{52624938-825D-4584-BBEB-AAA8C6E6296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5"/>
          <a:srcRect l="6494" t="46174" r="85536" b="45345"/>
          <a:stretch/>
        </p:blipFill>
        <p:spPr>
          <a:xfrm>
            <a:off x="5617031" y="668341"/>
            <a:ext cx="1086089" cy="650232"/>
          </a:xfrm>
          <a:prstGeom prst="rect">
            <a:avLst/>
          </a:prstGeom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xmlns="" id="{2DC1F713-4DB9-42DE-B957-547C8D5D637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446" t="21438" r="76188" b="72532"/>
          <a:stretch/>
        </p:blipFill>
        <p:spPr>
          <a:xfrm>
            <a:off x="7355445" y="1204871"/>
            <a:ext cx="686863" cy="94184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xmlns="" id="{2B827903-9E77-4465-AA07-23A5DF745675}"/>
              </a:ext>
            </a:extLst>
          </p:cNvPr>
          <p:cNvSpPr/>
          <p:nvPr/>
        </p:nvSpPr>
        <p:spPr>
          <a:xfrm>
            <a:off x="4929597" y="57029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xmlns="" id="{D58A6BA6-781A-49FB-833B-013A92AFDA92}"/>
              </a:ext>
            </a:extLst>
          </p:cNvPr>
          <p:cNvSpPr/>
          <p:nvPr/>
        </p:nvSpPr>
        <p:spPr>
          <a:xfrm>
            <a:off x="5031147" y="385533"/>
            <a:ext cx="2107543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24" name="Título 1">
            <a:extLst>
              <a:ext uri="{FF2B5EF4-FFF2-40B4-BE49-F238E27FC236}">
                <a16:creationId xmlns:a16="http://schemas.microsoft.com/office/drawing/2014/main" xmlns="" id="{6B245128-2116-465B-B4F6-6FD3C32DEE0D}"/>
              </a:ext>
            </a:extLst>
          </p:cNvPr>
          <p:cNvSpPr txBox="1">
            <a:spLocks/>
          </p:cNvSpPr>
          <p:nvPr/>
        </p:nvSpPr>
        <p:spPr>
          <a:xfrm>
            <a:off x="479230" y="905053"/>
            <a:ext cx="4252496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5- Locus Chr07g00585461. Putative protein kinase RLK-Pelle-RLCK-VIIa-2 family</a:t>
            </a:r>
          </a:p>
        </p:txBody>
      </p:sp>
    </p:spTree>
    <p:extLst>
      <p:ext uri="{BB962C8B-B14F-4D97-AF65-F5344CB8AC3E}">
        <p14:creationId xmlns:p14="http://schemas.microsoft.com/office/powerpoint/2010/main" val="82367304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027065" y="1247672"/>
            <a:ext cx="5690134" cy="169267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027065" y="3246365"/>
            <a:ext cx="5690134" cy="20368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8966" t="79693" r="34104" b="17770"/>
          <a:stretch/>
        </p:blipFill>
        <p:spPr>
          <a:xfrm>
            <a:off x="2025379" y="4964789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124640" y="3116690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12</a:t>
            </a:r>
            <a:r>
              <a:rPr lang="en-US" sz="1200" b="1" dirty="0"/>
              <a:t>)</a:t>
            </a:r>
            <a:endParaRPr lang="es-ES" sz="1200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xmlns="" id="{E64B1294-97A2-4D58-8A42-25882A346E1F}"/>
              </a:ext>
            </a:extLst>
          </p:cNvPr>
          <p:cNvSpPr/>
          <p:nvPr/>
        </p:nvSpPr>
        <p:spPr>
          <a:xfrm>
            <a:off x="1124638" y="1145071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17" name="Marcador de contenido 3">
            <a:extLst>
              <a:ext uri="{FF2B5EF4-FFF2-40B4-BE49-F238E27FC236}">
                <a16:creationId xmlns:a16="http://schemas.microsoft.com/office/drawing/2014/main" xmlns="" id="{3F12EF34-C565-4ECE-9F2C-6A8C173D7AB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23662" t="52312" r="27489" b="20209"/>
          <a:stretch/>
        </p:blipFill>
        <p:spPr>
          <a:xfrm>
            <a:off x="1124640" y="3472622"/>
            <a:ext cx="4366371" cy="1381547"/>
          </a:xfrm>
          <a:prstGeom prst="rect">
            <a:avLst/>
          </a:prstGeom>
        </p:spPr>
      </p:pic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777A7633-78B1-4A8D-BD22-D40675CB6B4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7504" t="45443" r="19257" b="28156"/>
          <a:stretch/>
        </p:blipFill>
        <p:spPr>
          <a:xfrm>
            <a:off x="1232974" y="1582639"/>
            <a:ext cx="5236506" cy="1229729"/>
          </a:xfrm>
          <a:prstGeom prst="rect">
            <a:avLst/>
          </a:prstGeom>
        </p:spPr>
      </p:pic>
      <p:sp>
        <p:nvSpPr>
          <p:cNvPr id="11" name="Título 1">
            <a:extLst>
              <a:ext uri="{FF2B5EF4-FFF2-40B4-BE49-F238E27FC236}">
                <a16:creationId xmlns:a16="http://schemas.microsoft.com/office/drawing/2014/main" xmlns="" id="{B0ACA624-EF33-42FE-972E-1CED265CDE7F}"/>
              </a:ext>
            </a:extLst>
          </p:cNvPr>
          <p:cNvSpPr txBox="1">
            <a:spLocks/>
          </p:cNvSpPr>
          <p:nvPr/>
        </p:nvSpPr>
        <p:spPr>
          <a:xfrm>
            <a:off x="507222" y="895689"/>
            <a:ext cx="7330492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6- Locus Chr07g00585521. Putative non-specific serine/threonine protein kinase</a:t>
            </a:r>
          </a:p>
        </p:txBody>
      </p:sp>
    </p:spTree>
    <p:extLst>
      <p:ext uri="{BB962C8B-B14F-4D97-AF65-F5344CB8AC3E}">
        <p14:creationId xmlns:p14="http://schemas.microsoft.com/office/powerpoint/2010/main" val="369642315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Marcador de contenido 9">
            <a:extLst>
              <a:ext uri="{FF2B5EF4-FFF2-40B4-BE49-F238E27FC236}">
                <a16:creationId xmlns:a16="http://schemas.microsoft.com/office/drawing/2014/main" xmlns="" id="{27C17109-9075-4AA7-9B64-991F6DA630E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6646" t="20059" r="75634" b="70773"/>
          <a:stretch/>
        </p:blipFill>
        <p:spPr>
          <a:xfrm>
            <a:off x="5212630" y="615876"/>
            <a:ext cx="2411491" cy="701807"/>
          </a:xfrm>
          <a:prstGeom prst="rect">
            <a:avLst/>
          </a:prstGeom>
        </p:spPr>
      </p:pic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449985"/>
            <a:ext cx="5690134" cy="28049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4420308"/>
            <a:ext cx="5690134" cy="17868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966" t="79693" r="34104" b="17770"/>
          <a:stretch/>
        </p:blipFill>
        <p:spPr>
          <a:xfrm>
            <a:off x="2522276" y="5920431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239287" y="4290632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93</a:t>
            </a:r>
            <a:r>
              <a:rPr lang="en-US" sz="1200" b="1" dirty="0"/>
              <a:t>)</a:t>
            </a:r>
            <a:endParaRPr lang="es-ES" sz="1200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xmlns="" id="{E64B1294-97A2-4D58-8A42-25882A346E1F}"/>
              </a:ext>
            </a:extLst>
          </p:cNvPr>
          <p:cNvSpPr/>
          <p:nvPr/>
        </p:nvSpPr>
        <p:spPr>
          <a:xfrm>
            <a:off x="1239285" y="1347383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3FB7B964-BA1C-40A7-B9F1-4F8150B401F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280" t="52539" r="27552" b="20055"/>
          <a:stretch/>
        </p:blipFill>
        <p:spPr>
          <a:xfrm>
            <a:off x="1325863" y="4550462"/>
            <a:ext cx="4185938" cy="1286304"/>
          </a:xfrm>
          <a:prstGeom prst="rect">
            <a:avLst/>
          </a:prstGeom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xmlns="" id="{868C9F2D-A898-4E34-A8EF-F3EAF108273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203" t="23603" r="18718" b="11090"/>
          <a:stretch/>
        </p:blipFill>
        <p:spPr>
          <a:xfrm>
            <a:off x="1670436" y="1585964"/>
            <a:ext cx="4624150" cy="2650890"/>
          </a:xfrm>
          <a:prstGeom prst="rect">
            <a:avLst/>
          </a:prstGeom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xmlns="" id="{38B0D593-9A8C-46D1-AC39-DAA4539E1C3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446" t="21438" r="76188" b="72532"/>
          <a:stretch/>
        </p:blipFill>
        <p:spPr>
          <a:xfrm>
            <a:off x="7355445" y="1204871"/>
            <a:ext cx="686863" cy="94184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xmlns="" id="{29ECF389-78A1-46B9-9CCD-59E193A6E912}"/>
              </a:ext>
            </a:extLst>
          </p:cNvPr>
          <p:cNvSpPr/>
          <p:nvPr/>
        </p:nvSpPr>
        <p:spPr>
          <a:xfrm>
            <a:off x="4929597" y="57029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xmlns="" id="{32BE1134-82EE-46B8-87D3-99A8FBE3C6E5}"/>
              </a:ext>
            </a:extLst>
          </p:cNvPr>
          <p:cNvSpPr/>
          <p:nvPr/>
        </p:nvSpPr>
        <p:spPr>
          <a:xfrm>
            <a:off x="5031147" y="385533"/>
            <a:ext cx="2107543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24" name="Título 1">
            <a:extLst>
              <a:ext uri="{FF2B5EF4-FFF2-40B4-BE49-F238E27FC236}">
                <a16:creationId xmlns:a16="http://schemas.microsoft.com/office/drawing/2014/main" xmlns="" id="{0145E3A5-C228-4723-A406-05A4BBDDD1AA}"/>
              </a:ext>
            </a:extLst>
          </p:cNvPr>
          <p:cNvSpPr txBox="1">
            <a:spLocks/>
          </p:cNvSpPr>
          <p:nvPr/>
        </p:nvSpPr>
        <p:spPr>
          <a:xfrm>
            <a:off x="479230" y="905053"/>
            <a:ext cx="4252496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7- Locus Chr07g005585531. </a:t>
            </a:r>
            <a:r>
              <a:rPr lang="es-ES" b="1" dirty="0" err="1"/>
              <a:t>Putative</a:t>
            </a:r>
            <a:r>
              <a:rPr lang="es-ES" b="1" dirty="0"/>
              <a:t> </a:t>
            </a:r>
            <a:r>
              <a:rPr lang="es-ES" b="1" dirty="0" err="1"/>
              <a:t>protein</a:t>
            </a:r>
            <a:r>
              <a:rPr lang="es-ES" b="1" dirty="0"/>
              <a:t> </a:t>
            </a:r>
            <a:r>
              <a:rPr lang="es-ES" b="1" dirty="0" err="1"/>
              <a:t>kinase</a:t>
            </a:r>
            <a:r>
              <a:rPr lang="es-ES" b="1" dirty="0"/>
              <a:t> RLK-Pelle-CrRLK1L-1 </a:t>
            </a:r>
            <a:r>
              <a:rPr lang="es-ES" b="1" dirty="0" err="1"/>
              <a:t>family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8874257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CE866C0C-A572-47BC-AD1A-0139B3A2122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591" t="51995" r="27394" b="24579"/>
          <a:stretch/>
        </p:blipFill>
        <p:spPr>
          <a:xfrm>
            <a:off x="1141712" y="4566023"/>
            <a:ext cx="4447140" cy="1171680"/>
          </a:xfrm>
          <a:prstGeom prst="rect">
            <a:avLst/>
          </a:prstGeom>
        </p:spPr>
      </p:pic>
      <p:pic>
        <p:nvPicPr>
          <p:cNvPr id="17" name="Marcador de contenido 4">
            <a:extLst>
              <a:ext uri="{FF2B5EF4-FFF2-40B4-BE49-F238E27FC236}">
                <a16:creationId xmlns:a16="http://schemas.microsoft.com/office/drawing/2014/main" xmlns="" id="{22D367B1-3866-406D-A8FA-A2FF2701C87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5773" t="40298" r="88959" b="51533"/>
          <a:stretch/>
        </p:blipFill>
        <p:spPr>
          <a:xfrm>
            <a:off x="6025475" y="621719"/>
            <a:ext cx="896027" cy="677336"/>
          </a:xfrm>
          <a:prstGeom prst="rect">
            <a:avLst/>
          </a:prstGeom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xmlns="" id="{A3DF0A8B-6F4A-4822-9F60-99E7F4C38D4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3368" t="25471" r="13632" b="10261"/>
          <a:stretch/>
        </p:blipFill>
        <p:spPr>
          <a:xfrm>
            <a:off x="1512070" y="1532377"/>
            <a:ext cx="5256263" cy="2603021"/>
          </a:xfrm>
          <a:prstGeom prst="rect">
            <a:avLst/>
          </a:prstGeom>
        </p:spPr>
      </p:pic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412661"/>
            <a:ext cx="5690134" cy="28049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4382984"/>
            <a:ext cx="5690134" cy="17796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28966" t="79693" r="34104" b="17770"/>
          <a:stretch/>
        </p:blipFill>
        <p:spPr>
          <a:xfrm>
            <a:off x="2452426" y="5867379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239287" y="4253308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36</a:t>
            </a:r>
            <a:r>
              <a:rPr lang="en-US" sz="1200" b="1" dirty="0"/>
              <a:t>)</a:t>
            </a:r>
            <a:endParaRPr lang="es-ES" sz="1200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xmlns="" id="{E64B1294-97A2-4D58-8A42-25882A346E1F}"/>
              </a:ext>
            </a:extLst>
          </p:cNvPr>
          <p:cNvSpPr/>
          <p:nvPr/>
        </p:nvSpPr>
        <p:spPr>
          <a:xfrm>
            <a:off x="1239285" y="1310059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21" name="Imagen 20">
            <a:extLst>
              <a:ext uri="{FF2B5EF4-FFF2-40B4-BE49-F238E27FC236}">
                <a16:creationId xmlns:a16="http://schemas.microsoft.com/office/drawing/2014/main" xmlns="" id="{810826B4-A3D7-4C45-8B54-60F68BE82E4A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446" t="21438" r="76188" b="72532"/>
          <a:stretch/>
        </p:blipFill>
        <p:spPr>
          <a:xfrm>
            <a:off x="7355445" y="1204871"/>
            <a:ext cx="686863" cy="94184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xmlns="" id="{12CF0EBB-8644-4DE3-BDC3-88166CA38EEA}"/>
              </a:ext>
            </a:extLst>
          </p:cNvPr>
          <p:cNvSpPr/>
          <p:nvPr/>
        </p:nvSpPr>
        <p:spPr>
          <a:xfrm>
            <a:off x="4929597" y="57029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xmlns="" id="{59C0BB6D-C1A9-4683-BA6F-00080925E1B6}"/>
              </a:ext>
            </a:extLst>
          </p:cNvPr>
          <p:cNvSpPr/>
          <p:nvPr/>
        </p:nvSpPr>
        <p:spPr>
          <a:xfrm>
            <a:off x="5031147" y="385533"/>
            <a:ext cx="2107543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24" name="Título 1">
            <a:extLst>
              <a:ext uri="{FF2B5EF4-FFF2-40B4-BE49-F238E27FC236}">
                <a16:creationId xmlns:a16="http://schemas.microsoft.com/office/drawing/2014/main" xmlns="" id="{D366F56E-AA3C-4E10-8497-DF5B5D68BDA0}"/>
              </a:ext>
            </a:extLst>
          </p:cNvPr>
          <p:cNvSpPr txBox="1">
            <a:spLocks/>
          </p:cNvSpPr>
          <p:nvPr/>
        </p:nvSpPr>
        <p:spPr>
          <a:xfrm>
            <a:off x="479230" y="905053"/>
            <a:ext cx="4252496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8- Locus Chr07g00585541. Putative protein kinase RLK-Pelle-RLCK-VIIa-2 family</a:t>
            </a:r>
          </a:p>
        </p:txBody>
      </p:sp>
    </p:spTree>
    <p:extLst>
      <p:ext uri="{BB962C8B-B14F-4D97-AF65-F5344CB8AC3E}">
        <p14:creationId xmlns:p14="http://schemas.microsoft.com/office/powerpoint/2010/main" val="150758498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Marcador de contenido 4">
            <a:extLst>
              <a:ext uri="{FF2B5EF4-FFF2-40B4-BE49-F238E27FC236}">
                <a16:creationId xmlns:a16="http://schemas.microsoft.com/office/drawing/2014/main" xmlns="" id="{61AC7C5E-3BBB-4522-90F4-F9C5E51165C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5786" t="42896" r="85058" b="47477"/>
          <a:stretch/>
        </p:blipFill>
        <p:spPr>
          <a:xfrm>
            <a:off x="5805199" y="629102"/>
            <a:ext cx="1453115" cy="859316"/>
          </a:xfrm>
          <a:prstGeom prst="rect">
            <a:avLst/>
          </a:prstGeom>
        </p:spPr>
      </p:pic>
      <p:sp>
        <p:nvSpPr>
          <p:cNvPr id="12" name="Rectángulo 11">
            <a:extLst>
              <a:ext uri="{FF2B5EF4-FFF2-40B4-BE49-F238E27FC236}">
                <a16:creationId xmlns:a16="http://schemas.microsoft.com/office/drawing/2014/main" xmlns="" id="{84C17313-F816-43D7-9FA3-097EF05F677E}"/>
              </a:ext>
            </a:extLst>
          </p:cNvPr>
          <p:cNvSpPr/>
          <p:nvPr/>
        </p:nvSpPr>
        <p:spPr>
          <a:xfrm>
            <a:off x="1141712" y="1450761"/>
            <a:ext cx="5690134" cy="28049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13" name="Rectángulo 12">
            <a:extLst>
              <a:ext uri="{FF2B5EF4-FFF2-40B4-BE49-F238E27FC236}">
                <a16:creationId xmlns:a16="http://schemas.microsoft.com/office/drawing/2014/main" xmlns="" id="{A557EB01-213C-49F6-80F5-40BEA97DD137}"/>
              </a:ext>
            </a:extLst>
          </p:cNvPr>
          <p:cNvSpPr/>
          <p:nvPr/>
        </p:nvSpPr>
        <p:spPr>
          <a:xfrm>
            <a:off x="1141712" y="4421084"/>
            <a:ext cx="5690134" cy="15955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pic>
        <p:nvPicPr>
          <p:cNvPr id="15" name="Imagen 14">
            <a:extLst>
              <a:ext uri="{FF2B5EF4-FFF2-40B4-BE49-F238E27FC236}">
                <a16:creationId xmlns:a16="http://schemas.microsoft.com/office/drawing/2014/main" xmlns="" id="{4BE13BBD-827C-4645-AC93-55A136D2005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8966" t="79693" r="34104" b="17770"/>
          <a:stretch/>
        </p:blipFill>
        <p:spPr>
          <a:xfrm>
            <a:off x="2260751" y="5782816"/>
            <a:ext cx="4229642" cy="163458"/>
          </a:xfrm>
          <a:prstGeom prst="rect">
            <a:avLst/>
          </a:prstGeom>
        </p:spPr>
      </p:pic>
      <p:sp>
        <p:nvSpPr>
          <p:cNvPr id="14" name="Rectángulo 13">
            <a:extLst>
              <a:ext uri="{FF2B5EF4-FFF2-40B4-BE49-F238E27FC236}">
                <a16:creationId xmlns:a16="http://schemas.microsoft.com/office/drawing/2014/main" xmlns="" id="{0EF98CCB-20E4-4709-B9E2-6F94EFD29DFD}"/>
              </a:ext>
            </a:extLst>
          </p:cNvPr>
          <p:cNvSpPr/>
          <p:nvPr/>
        </p:nvSpPr>
        <p:spPr>
          <a:xfrm>
            <a:off x="1239287" y="4291408"/>
            <a:ext cx="3169329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/>
              <a:t>TAIR </a:t>
            </a:r>
            <a:r>
              <a:rPr lang="en-US" sz="1200" b="1" dirty="0" err="1"/>
              <a:t>BlastP</a:t>
            </a:r>
            <a:r>
              <a:rPr lang="en-US" sz="1200" b="1" dirty="0"/>
              <a:t> results (e-value lower than </a:t>
            </a:r>
            <a:r>
              <a:rPr lang="es-ES" sz="1200" b="1" dirty="0"/>
              <a:t>1x10</a:t>
            </a:r>
            <a:r>
              <a:rPr lang="es-ES" sz="1200" b="1" baseline="30000" dirty="0"/>
              <a:t>-51</a:t>
            </a:r>
            <a:r>
              <a:rPr lang="en-US" sz="1200" b="1" dirty="0"/>
              <a:t>)</a:t>
            </a:r>
            <a:endParaRPr lang="es-ES" sz="1200" dirty="0"/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xmlns="" id="{E64B1294-97A2-4D58-8A42-25882A346E1F}"/>
              </a:ext>
            </a:extLst>
          </p:cNvPr>
          <p:cNvSpPr/>
          <p:nvPr/>
        </p:nvSpPr>
        <p:spPr>
          <a:xfrm>
            <a:off x="1239285" y="1348159"/>
            <a:ext cx="2042932" cy="276999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sz="1200" b="1" dirty="0" err="1"/>
              <a:t>InterPro</a:t>
            </a:r>
            <a:r>
              <a:rPr lang="en-US" sz="1200" b="1" dirty="0"/>
              <a:t> domain constitution</a:t>
            </a:r>
            <a:endParaRPr lang="es-ES" sz="1200" dirty="0"/>
          </a:p>
        </p:txBody>
      </p:sp>
      <p:pic>
        <p:nvPicPr>
          <p:cNvPr id="18" name="Imagen 17">
            <a:extLst>
              <a:ext uri="{FF2B5EF4-FFF2-40B4-BE49-F238E27FC236}">
                <a16:creationId xmlns:a16="http://schemas.microsoft.com/office/drawing/2014/main" xmlns="" id="{8FEE4592-A45B-4BCC-8821-4AC1361282A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2962" t="52314" r="27600" b="23005"/>
          <a:stretch/>
        </p:blipFill>
        <p:spPr>
          <a:xfrm>
            <a:off x="1180790" y="4568407"/>
            <a:ext cx="4090851" cy="1148817"/>
          </a:xfrm>
          <a:prstGeom prst="rect">
            <a:avLst/>
          </a:prstGeom>
        </p:spPr>
      </p:pic>
      <p:pic>
        <p:nvPicPr>
          <p:cNvPr id="19" name="Imagen 18">
            <a:extLst>
              <a:ext uri="{FF2B5EF4-FFF2-40B4-BE49-F238E27FC236}">
                <a16:creationId xmlns:a16="http://schemas.microsoft.com/office/drawing/2014/main" xmlns="" id="{0F44D78E-E7D3-4F0A-9E02-EF03E6F8E4A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7579" t="25740" r="19469" b="7084"/>
          <a:stretch/>
        </p:blipFill>
        <p:spPr>
          <a:xfrm>
            <a:off x="1682409" y="1591617"/>
            <a:ext cx="4271079" cy="2563667"/>
          </a:xfrm>
          <a:prstGeom prst="rect">
            <a:avLst/>
          </a:prstGeom>
        </p:spPr>
      </p:pic>
      <p:pic>
        <p:nvPicPr>
          <p:cNvPr id="21" name="Imagen 20">
            <a:extLst>
              <a:ext uri="{FF2B5EF4-FFF2-40B4-BE49-F238E27FC236}">
                <a16:creationId xmlns:a16="http://schemas.microsoft.com/office/drawing/2014/main" xmlns="" id="{076EC7C3-4467-49F2-9896-8FC8334D0C2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1446" t="21438" r="76188" b="72532"/>
          <a:stretch/>
        </p:blipFill>
        <p:spPr>
          <a:xfrm>
            <a:off x="7355445" y="1204871"/>
            <a:ext cx="686863" cy="94184"/>
          </a:xfrm>
          <a:prstGeom prst="rect">
            <a:avLst/>
          </a:prstGeom>
        </p:spPr>
      </p:pic>
      <p:sp>
        <p:nvSpPr>
          <p:cNvPr id="22" name="Rectángulo 21">
            <a:extLst>
              <a:ext uri="{FF2B5EF4-FFF2-40B4-BE49-F238E27FC236}">
                <a16:creationId xmlns:a16="http://schemas.microsoft.com/office/drawing/2014/main" xmlns="" id="{F0073220-79FB-4847-8640-268CADDC7892}"/>
              </a:ext>
            </a:extLst>
          </p:cNvPr>
          <p:cNvSpPr/>
          <p:nvPr/>
        </p:nvSpPr>
        <p:spPr>
          <a:xfrm>
            <a:off x="4929597" y="570291"/>
            <a:ext cx="3169031" cy="79973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>
              <a:noFill/>
            </a:endParaRPr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xmlns="" id="{E5BF3402-01E4-43B4-8EFE-EF5D5001DC80}"/>
              </a:ext>
            </a:extLst>
          </p:cNvPr>
          <p:cNvSpPr/>
          <p:nvPr/>
        </p:nvSpPr>
        <p:spPr>
          <a:xfrm>
            <a:off x="5031147" y="385533"/>
            <a:ext cx="2107543" cy="276999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sz="1200" b="1" dirty="0" err="1"/>
              <a:t>Prosite</a:t>
            </a:r>
            <a:r>
              <a:rPr lang="en-US" sz="1200" b="1" dirty="0"/>
              <a:t> domain constitution</a:t>
            </a:r>
            <a:endParaRPr lang="es-ES" sz="1200" b="1" dirty="0"/>
          </a:p>
        </p:txBody>
      </p:sp>
      <p:sp>
        <p:nvSpPr>
          <p:cNvPr id="24" name="Título 1">
            <a:extLst>
              <a:ext uri="{FF2B5EF4-FFF2-40B4-BE49-F238E27FC236}">
                <a16:creationId xmlns:a16="http://schemas.microsoft.com/office/drawing/2014/main" xmlns="" id="{DE2D380E-772E-4067-B4C2-DC061D0CD1B8}"/>
              </a:ext>
            </a:extLst>
          </p:cNvPr>
          <p:cNvSpPr txBox="1">
            <a:spLocks/>
          </p:cNvSpPr>
          <p:nvPr/>
        </p:nvSpPr>
        <p:spPr>
          <a:xfrm>
            <a:off x="479230" y="905053"/>
            <a:ext cx="4252496" cy="249380"/>
          </a:xfrm>
          <a:prstGeom prst="rect">
            <a:avLst/>
          </a:prstGeom>
        </p:spPr>
        <p:txBody>
          <a:bodyPr vert="horz" lIns="19627" tIns="9814" rIns="19627" bIns="9814" rtlCol="0" anchor="b">
            <a:noAutofit/>
          </a:bodyPr>
          <a:lstStyle>
            <a:lvl1pPr algn="ctr">
              <a:lnSpc>
                <a:spcPct val="90000"/>
              </a:lnSpc>
              <a:spcBef>
                <a:spcPct val="0"/>
              </a:spcBef>
              <a:buNone/>
              <a:defRPr>
                <a:latin typeface="+mj-lt"/>
                <a:ea typeface="+mj-ea"/>
                <a:cs typeface="+mj-cs"/>
              </a:defRPr>
            </a:lvl1pPr>
          </a:lstStyle>
          <a:p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/>
            </a:r>
            <a:br>
              <a:rPr lang="en-US" b="1" dirty="0"/>
            </a:br>
            <a:r>
              <a:rPr lang="en-US" b="1" dirty="0"/>
              <a:t>9- Locus Chr07g00585551. </a:t>
            </a:r>
            <a:r>
              <a:rPr lang="es-ES" b="1" dirty="0" err="1"/>
              <a:t>Putative</a:t>
            </a:r>
            <a:r>
              <a:rPr lang="es-ES" b="1" dirty="0"/>
              <a:t> </a:t>
            </a:r>
            <a:r>
              <a:rPr lang="es-ES" b="1" dirty="0" err="1"/>
              <a:t>protein</a:t>
            </a:r>
            <a:r>
              <a:rPr lang="es-ES" b="1" dirty="0"/>
              <a:t> </a:t>
            </a:r>
            <a:r>
              <a:rPr lang="es-ES" b="1" dirty="0" err="1"/>
              <a:t>kinase</a:t>
            </a:r>
            <a:r>
              <a:rPr lang="es-ES" b="1" dirty="0"/>
              <a:t> RLK-Pelle-CrRLK1L-1 </a:t>
            </a:r>
            <a:r>
              <a:rPr lang="es-ES" b="1" dirty="0" err="1"/>
              <a:t>family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77416867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7</TotalTime>
  <Words>199</Words>
  <Application>Microsoft Office PowerPoint</Application>
  <PresentationFormat>Personalizado</PresentationFormat>
  <Paragraphs>45</Paragraphs>
  <Slides>1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1</vt:i4>
      </vt:variant>
    </vt:vector>
  </HeadingPairs>
  <TitlesOfParts>
    <vt:vector size="12" baseType="lpstr"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anom_Chr07g00585341 gn=HanomChr07g00585341 len=588 chr=HanomChr07 strand=1 sp=HANOM def=Putative protein kinase RLK-Pelle-RLCK-VIIa-2 family</dc:title>
  <dc:creator>Belen Fernandez</dc:creator>
  <cp:lastModifiedBy>Bego</cp:lastModifiedBy>
  <cp:revision>47</cp:revision>
  <dcterms:created xsi:type="dcterms:W3CDTF">2023-01-11T12:04:21Z</dcterms:created>
  <dcterms:modified xsi:type="dcterms:W3CDTF">2023-09-20T09:21:11Z</dcterms:modified>
</cp:coreProperties>
</file>